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12" userDrawn="1">
          <p15:clr>
            <a:srgbClr val="A4A3A4"/>
          </p15:clr>
        </p15:guide>
        <p15:guide id="2" pos="381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212"/>
        <p:guide pos="3816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emf"/><Relationship Id="rId8" Type="http://schemas.openxmlformats.org/officeDocument/2006/relationships/image" Target="../media/image8.emf"/><Relationship Id="rId7" Type="http://schemas.openxmlformats.org/officeDocument/2006/relationships/image" Target="../media/image7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1" Type="http://schemas.openxmlformats.org/officeDocument/2006/relationships/slideLayout" Target="../slideLayouts/slideLayout1.xml"/><Relationship Id="rId10" Type="http://schemas.openxmlformats.org/officeDocument/2006/relationships/tags" Target="../tags/tag63.xml"/><Relationship Id="rId1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18.emf"/><Relationship Id="rId8" Type="http://schemas.openxmlformats.org/officeDocument/2006/relationships/image" Target="../media/image17.emf"/><Relationship Id="rId7" Type="http://schemas.openxmlformats.org/officeDocument/2006/relationships/image" Target="../media/image16.emf"/><Relationship Id="rId6" Type="http://schemas.openxmlformats.org/officeDocument/2006/relationships/image" Target="../media/image15.emf"/><Relationship Id="rId5" Type="http://schemas.openxmlformats.org/officeDocument/2006/relationships/image" Target="../media/image14.emf"/><Relationship Id="rId4" Type="http://schemas.openxmlformats.org/officeDocument/2006/relationships/image" Target="../media/image13.emf"/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1" Type="http://schemas.openxmlformats.org/officeDocument/2006/relationships/slideLayout" Target="../slideLayouts/slideLayout2.xml"/><Relationship Id="rId10" Type="http://schemas.openxmlformats.org/officeDocument/2006/relationships/tags" Target="../tags/tag64.xml"/><Relationship Id="rId1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0" y="0"/>
            <a:ext cx="2564765" cy="218122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0195" y="29210"/>
            <a:ext cx="2888615" cy="215201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31230" y="116205"/>
            <a:ext cx="2924175" cy="2147570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89415" y="194945"/>
            <a:ext cx="2763520" cy="203835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2233295"/>
            <a:ext cx="2576195" cy="221869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10510" y="2346325"/>
            <a:ext cx="2908300" cy="224218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09005" y="2480945"/>
            <a:ext cx="2976880" cy="2107565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289415" y="2490470"/>
            <a:ext cx="2763520" cy="201549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6040" y="4588510"/>
            <a:ext cx="2786380" cy="2084070"/>
          </a:xfrm>
          <a:prstGeom prst="rect">
            <a:avLst/>
          </a:prstGeom>
        </p:spPr>
      </p:pic>
      <p:sp>
        <p:nvSpPr>
          <p:cNvPr id="2" name="文本框 1"/>
          <p:cNvSpPr txBox="1"/>
          <p:nvPr/>
        </p:nvSpPr>
        <p:spPr>
          <a:xfrm>
            <a:off x="3550920" y="5655310"/>
            <a:ext cx="8150225" cy="30670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Supplementary Figure 1A. Bland-Altman plots for intraobserver variability.</a:t>
            </a:r>
            <a:endParaRPr lang="en-US" altLang="zh-CN" sz="14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10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5" name="图片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78435" y="57785"/>
            <a:ext cx="2691765" cy="2244725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66745" y="31115"/>
            <a:ext cx="2813685" cy="2282825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70930" y="176530"/>
            <a:ext cx="2846705" cy="213741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50045" y="196215"/>
            <a:ext cx="2929890" cy="2125345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8745" y="2430780"/>
            <a:ext cx="2751455" cy="216344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89580" y="2477135"/>
            <a:ext cx="2943225" cy="2228850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57900" y="2493645"/>
            <a:ext cx="2947670" cy="2228850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253220" y="2493010"/>
            <a:ext cx="2835910" cy="2296795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8745" y="4722495"/>
            <a:ext cx="2810510" cy="2008505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749040" y="5774690"/>
            <a:ext cx="6096000" cy="30670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 algn="l">
              <a:buClrTx/>
              <a:buSzTx/>
              <a:buFontTx/>
            </a:pPr>
            <a:r>
              <a:rPr lang="en-US" altLang="zh-CN" sz="1400">
                <a:latin typeface="Times New Roman" panose="02020603050405020304" charset="0"/>
                <a:cs typeface="Times New Roman" panose="02020603050405020304" charset="0"/>
              </a:rPr>
              <a:t>Supplementary Figure 1B. Bland-Altman plots for interobserver variability.</a:t>
            </a:r>
            <a:endParaRPr lang="en-US" altLang="zh-CN" sz="1400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10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4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8</Words>
  <Application>WPS 演示</Application>
  <PresentationFormat>宽屏</PresentationFormat>
  <Paragraphs>4</Paragraphs>
  <Slides>2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1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WPS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～～木&amp;子「金」</cp:lastModifiedBy>
  <cp:revision>161</cp:revision>
  <dcterms:created xsi:type="dcterms:W3CDTF">2019-06-19T02:08:00Z</dcterms:created>
  <dcterms:modified xsi:type="dcterms:W3CDTF">2025-01-31T13:30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9770</vt:lpwstr>
  </property>
  <property fmtid="{D5CDD505-2E9C-101B-9397-08002B2CF9AE}" pid="3" name="ICV">
    <vt:lpwstr>B419A6AD13444476941C41C471277D29_11</vt:lpwstr>
  </property>
</Properties>
</file>